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20" y="2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154500-B79A-B4D5-14A9-A7AF3E5A9B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6DDE3C0-FB01-16A6-6F7D-F08DA86F33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C57B5F-0732-D203-05E8-E06F2E1DE6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8D69-C81D-49D2-9D47-DD2894CBE9B9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3CFA44-1694-0684-35CC-484E94906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38FA6C-5BE1-2414-3A31-C090F3D60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E89C5-063D-4569-A3E5-881365438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014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B779AF-B9A4-CD80-E555-4ABF360E0A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52A12A-A951-3A47-9E41-95AB0DF6AC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0EE71D-B230-8308-7925-7C493DCCAA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8D69-C81D-49D2-9D47-DD2894CBE9B9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F48FE6-B7CC-3B28-65C6-D0225B471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E28BBB-FA6C-B8F0-6F86-3C5F8E87E7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E89C5-063D-4569-A3E5-881365438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258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F500F61-03C6-46DF-56CA-835838B465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53E7822-B71E-1222-D90C-CEBB102925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14FD18-7AA7-2676-A288-B466FD0A4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8D69-C81D-49D2-9D47-DD2894CBE9B9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D460AC-0F49-F390-0C52-34C365842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38FE16-65CA-42FF-4C3E-531E22C62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E89C5-063D-4569-A3E5-881365438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556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638692-4302-FEA1-DE49-1D060F397B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A9EADC-BE52-0E64-2C82-8E357DD544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05FEF7-1DCF-2C45-5E32-05D5BE1BD9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8D69-C81D-49D2-9D47-DD2894CBE9B9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0A7410-7BA4-3F63-2C14-7C21840CA2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39AA0F-CDB6-3742-8B37-293FFDC350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E89C5-063D-4569-A3E5-881365438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649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47A038-1262-7AAC-44E8-8BF221B04A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357DA0-D9D4-A998-9433-4AE19FF063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A15827-3D6E-8697-83A3-9105A6A38D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8D69-C81D-49D2-9D47-DD2894CBE9B9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88FD27-A503-5671-7D02-3CE90B7269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0CA8BF-5029-8090-D7DD-2BB61D04D6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E89C5-063D-4569-A3E5-881365438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295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E0862D-C84C-620E-18B7-5652735620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3D0703-A021-EE39-6473-58F021FBA2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F3B742-E745-9F68-1AFE-A5BFFD0E59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685DE9-3704-13C6-CE3A-8541F90DF3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8D69-C81D-49D2-9D47-DD2894CBE9B9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B1B11D-77DA-2587-D538-3024CF0462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EFE081-9D5B-4975-F76C-90FB17F22D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E89C5-063D-4569-A3E5-881365438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367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AF4912-8004-D3D1-B342-F4701297F9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AC5893-E970-5995-15FB-5A264AEF05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F24BC3-B3B9-E49D-E3DD-38F0B13919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07CD62F-3FE6-1F2D-B3AB-CA28660733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A872C44-DF2D-E13E-960B-E846F2209EF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967920F-3A9A-603C-574D-BC899EE83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8D69-C81D-49D2-9D47-DD2894CBE9B9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16FA0A5-CE0A-FF0C-4E64-4ECD2B69E9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A27F196-F131-E223-CBEA-68AFA2B09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E89C5-063D-4569-A3E5-881365438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2239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B59024-1D49-56B5-1548-2872F464BF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3502050-9C90-F8E8-1EE0-0F3F21F078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8D69-C81D-49D2-9D47-DD2894CBE9B9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B8CB6CC-8FC2-3E1D-591C-4CD62DB296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6EF21B-CA40-FBFC-AF1D-B4D5A3D2A6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E89C5-063D-4569-A3E5-881365438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2450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FAF2CC-8C73-9425-5139-7C334FE62C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8D69-C81D-49D2-9D47-DD2894CBE9B9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909EBB1-03C5-5ECA-378E-B8D973B144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045E52-2A6D-1223-A14B-7D9BA3C6CA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E89C5-063D-4569-A3E5-881365438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95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EF35AF-F327-41EE-7E0F-93EA083F4A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385F9B-81DD-D47F-8D2D-08F3A884F2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02E3D01-C087-589E-1904-82433707A5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D5B5FE-242D-8CF0-BCFB-BC6105244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8D69-C81D-49D2-9D47-DD2894CBE9B9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A66CE9-E0D5-8353-33EA-91571EE6C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C223B3-0B65-F103-ECE9-682DBFA5DE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E89C5-063D-4569-A3E5-881365438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9735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E1F68A-6227-C67B-E293-D4611AC86A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045E743-F0CC-20FE-50C3-FC7393CD4B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E9AD63-1E1B-E88E-6DFE-D164B890D0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44D9EA-437E-B3EE-237C-500CF1B0D6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28D69-C81D-49D2-9D47-DD2894CBE9B9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9DD140-1829-A3E8-08D3-369DE9874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7853B2-4F00-62E2-4153-C5577535EE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E89C5-063D-4569-A3E5-881365438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3012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937AC4A-28A4-F808-39B2-4D3D73F4C7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0B012D-8643-469C-9B09-190C1258C9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A91D75-BB03-02E4-F96B-A14EFBCBBE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C28D69-C81D-49D2-9D47-DD2894CBE9B9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6DD060-D8D3-5637-937C-C6FC9CB539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82CDF2-9EBA-0521-3726-0E70A7D48B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DE89C5-063D-4569-A3E5-881365438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975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text, font, screenshot&#10;&#10;Description automatically generated">
            <a:extLst>
              <a:ext uri="{FF2B5EF4-FFF2-40B4-BE49-F238E27FC236}">
                <a16:creationId xmlns:a16="http://schemas.microsoft.com/office/drawing/2014/main" id="{876EDB19-AFE1-EBA4-40B4-BC62888D378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453" y="149751"/>
            <a:ext cx="11496652" cy="2557544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8B6D4ED-C5BF-D52C-F3CB-AF56BF709DCF}"/>
              </a:ext>
            </a:extLst>
          </p:cNvPr>
          <p:cNvSpPr txBox="1"/>
          <p:nvPr/>
        </p:nvSpPr>
        <p:spPr>
          <a:xfrm>
            <a:off x="434203" y="2867149"/>
            <a:ext cx="1067860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ry Figure 3. Kinetics of Bleomycin-induced DNA-PK phosphorylation by ZL-2201. </a:t>
            </a:r>
            <a:r>
              <a:rPr lang="en-US" sz="1600" dirty="0"/>
              <a:t>(A) NCI-H1703 cells were pre-treated with bleomycin for 2-hours followed by ZL-2201 treatment at 3 different concentrations (0.1, 0.6 and 2uM) for 0.5, 2, 6 and 24 hours. (B) NCI-H1703 cells were pre-treated with ZL-2201 at the indicated concentrations for 2-hours followed by 10uM bleomycin treatment for the indicated times. Immunoblotting was performed for phospho-DNA-PK (Ser2056), total DNA-PK and the loading control GAPDH using Simple Western system. </a:t>
            </a:r>
          </a:p>
        </p:txBody>
      </p:sp>
    </p:spTree>
    <p:extLst>
      <p:ext uri="{BB962C8B-B14F-4D97-AF65-F5344CB8AC3E}">
        <p14:creationId xmlns:p14="http://schemas.microsoft.com/office/powerpoint/2010/main" val="25823024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il Bhola</dc:creator>
  <cp:lastModifiedBy>Neil Bhola</cp:lastModifiedBy>
  <cp:revision>1</cp:revision>
  <dcterms:created xsi:type="dcterms:W3CDTF">2023-07-28T20:44:06Z</dcterms:created>
  <dcterms:modified xsi:type="dcterms:W3CDTF">2023-07-28T20:44:42Z</dcterms:modified>
</cp:coreProperties>
</file>